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64" r:id="rId2"/>
    <p:sldId id="279" r:id="rId3"/>
    <p:sldId id="306" r:id="rId4"/>
    <p:sldId id="300" r:id="rId5"/>
    <p:sldId id="278" r:id="rId6"/>
    <p:sldId id="304" r:id="rId7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44546A"/>
    <a:srgbClr val="5B9BD5"/>
    <a:srgbClr val="0000B2"/>
    <a:srgbClr val="ED7D31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2458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../embeddings/oleObject1.bin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J:\1-paper%20related-20200716&#22791;&#20221;\5.5%20&#23435;&#20029;-&#28504;&#36126;&#24535;-&#24178;&#26097;&#19979;&#21487;&#21464;&#24615;&#21098;&#20999;&#30740;&#31350;\&#25991;&#31456;&#25968;&#25454;&#21450;&#20316;&#22270;&#25968;&#25454;&#21644;&#20316;&#22270;\Figure%202.5-&#32858;&#31867;&#20998;&#26512;\&#20174;&#19981;&#21516;&#32858;&#31867;&#20013;&#36873;&#25321;&#22522;&#22240;&#30340;&#34920;&#26684;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J:\1-paper%20related-20200716&#22791;&#20221;\5.5%20&#23435;&#20029;-&#28504;&#36126;&#24535;-&#24178;&#26097;&#19979;&#21487;&#21464;&#24615;&#21098;&#20999;&#30740;&#31350;\&#25991;&#31456;&#25968;&#25454;&#21450;&#20316;&#22270;&#25968;&#25454;&#21644;&#20316;&#22270;\Figure%202.5-&#32858;&#31867;&#20998;&#26512;\&#20174;&#19981;&#21516;&#32858;&#31867;&#20013;&#36873;&#25321;&#22522;&#22240;&#30340;&#34920;&#26684;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J:\1-paper%20related-20200716&#22791;&#20221;\5.5%20&#23435;&#20029;-&#28504;&#36126;&#24535;-&#24178;&#26097;&#19979;&#21487;&#21464;&#24615;&#21098;&#20999;&#30740;&#31350;\&#25991;&#31456;&#25968;&#25454;&#21450;&#20316;&#22270;&#25968;&#25454;&#21644;&#20316;&#22270;\Figure%202.5-&#32858;&#31867;&#20998;&#26512;\&#20174;&#19981;&#21516;&#32858;&#31867;&#20013;&#36873;&#25321;&#22522;&#22240;&#30340;&#34920;&#26684;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J:\1-paper%20related-20200716&#22791;&#20221;\5.5%20&#23435;&#20029;-&#28504;&#36126;&#24535;-&#24178;&#26097;&#19979;&#21487;&#21464;&#24615;&#21098;&#20999;&#30740;&#31350;\&#25991;&#31456;&#25968;&#25454;&#21450;&#20316;&#22270;&#25968;&#25454;&#21644;&#20316;&#22270;\Figure%202.5-&#32858;&#31867;&#20998;&#26512;\&#20174;&#19981;&#21516;&#32858;&#31867;&#20013;&#36873;&#25321;&#22522;&#22240;&#30340;&#34920;&#26684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J:\1-paper%20related-20200716&#22791;&#20221;\5.5%20&#23435;&#20029;-&#28504;&#36126;&#24535;-&#24178;&#26097;&#19979;&#21487;&#21464;&#24615;&#21098;&#20999;&#30740;&#31350;\&#25991;&#31456;&#25968;&#25454;&#21450;&#20316;&#22270;&#25968;&#25454;&#21644;&#20316;&#22270;\Figure%202.5-&#32858;&#31867;&#20998;&#26512;\&#20174;&#19981;&#21516;&#32858;&#31867;&#20013;&#36873;&#25321;&#22522;&#22240;&#30340;&#34920;&#26684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J:\1-paper%20related-20200716&#22791;&#20221;\5.5%20&#23435;&#20029;-&#28504;&#36126;&#24535;-&#24178;&#26097;&#19979;&#21487;&#21464;&#24615;&#21098;&#20999;&#30740;&#31350;\&#25991;&#31456;&#25968;&#25454;&#21450;&#20316;&#22270;&#25968;&#25454;&#21644;&#20316;&#22270;\Figure%202.5-&#32858;&#31867;&#20998;&#26512;\&#20174;&#19981;&#21516;&#32858;&#31867;&#20013;&#36873;&#25321;&#22522;&#22240;&#30340;&#34920;&#26684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J:\1-paper%20related-20200716&#22791;&#20221;\5.5%20&#23435;&#20029;-&#28504;&#36126;&#24535;-&#24178;&#26097;&#19979;&#21487;&#21464;&#24615;&#21098;&#20999;&#30740;&#31350;\&#25991;&#31456;&#25968;&#25454;&#21450;&#20316;&#22270;&#25968;&#25454;&#21644;&#20316;&#22270;\Figure%202.5-&#32858;&#31867;&#20998;&#26512;\&#20174;&#19981;&#21516;&#32858;&#31867;&#20013;&#36873;&#25321;&#22522;&#22240;&#30340;&#34920;&#26684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J:\1-paper%20related-20200716&#22791;&#20221;\5.5%20&#23435;&#20029;-&#28504;&#36126;&#24535;-&#24178;&#26097;&#19979;&#21487;&#21464;&#24615;&#21098;&#20999;&#30740;&#31350;\&#25991;&#31456;&#25968;&#25454;&#21450;&#20316;&#22270;&#25968;&#25454;&#21644;&#20316;&#22270;\Figure%202.5-&#32858;&#31867;&#20998;&#26512;\&#20174;&#19981;&#21516;&#32858;&#31867;&#20013;&#36873;&#25321;&#22522;&#22240;&#30340;&#34920;&#26684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J:\1-paper%20related-20200716&#22791;&#20221;\5.5%20&#23435;&#20029;-&#28504;&#36126;&#24535;-&#24178;&#26097;&#19979;&#21487;&#21464;&#24615;&#21098;&#20999;&#30740;&#31350;\&#25991;&#31456;&#25968;&#25454;&#21450;&#20316;&#22270;&#25968;&#25454;&#21644;&#20316;&#22270;\Figure%202.5-&#32858;&#31867;&#20998;&#26512;\&#20174;&#19981;&#21516;&#32858;&#31867;&#20013;&#36873;&#25321;&#22522;&#22240;&#30340;&#34920;&#26684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J:\1-paper%20related-20200716&#22791;&#20221;\5.5%20&#23435;&#20029;-&#28504;&#36126;&#24535;-&#24178;&#26097;&#19979;&#21487;&#21464;&#24615;&#21098;&#20999;&#30740;&#31350;\&#25991;&#31456;&#25968;&#25454;&#21450;&#20316;&#22270;&#25968;&#25454;&#21644;&#20316;&#22270;\Figure%202.5-&#32858;&#31867;&#20998;&#26512;\&#20174;&#19981;&#21516;&#32858;&#31867;&#20013;&#36873;&#25321;&#22522;&#22240;&#30340;&#34920;&#26684;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J:\1-paper%20related-20200716&#22791;&#20221;\5.5%20&#23435;&#20029;-&#28504;&#36126;&#24535;-&#24178;&#26097;&#19979;&#21487;&#21464;&#24615;&#21098;&#20999;&#30740;&#31350;\&#25991;&#31456;&#25968;&#25454;&#21450;&#20316;&#22270;&#25968;&#25454;&#21644;&#20316;&#22270;\Figure%202.5-&#32858;&#31867;&#20998;&#26512;\&#20174;&#19981;&#21516;&#32858;&#31867;&#20013;&#36873;&#25321;&#22522;&#22240;&#30340;&#34920;&#26684;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pieChart>
        <c:varyColors val="1"/>
        <c:ser>
          <c:idx val="0"/>
          <c:order val="0"/>
          <c:tx>
            <c:strRef>
              <c:f>'[可变剪切事件统计表2020-05-02.xls]root '!$J$33</c:f>
              <c:strCache>
                <c:ptCount val="1"/>
                <c:pt idx="0">
                  <c:v>VMS_WW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>
                <a:outerShdw blurRad="317500" algn="ctr" rotWithShape="0">
                  <a:prstClr val="black">
                    <a:alpha val="25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0C88-49BF-BA6A-CBB572877175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317500" algn="ctr" rotWithShape="0">
                  <a:prstClr val="black">
                    <a:alpha val="25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0C88-49BF-BA6A-CBB572877175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>
                <a:outerShdw blurRad="317500" algn="ctr" rotWithShape="0">
                  <a:prstClr val="black">
                    <a:alpha val="25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0C88-49BF-BA6A-CBB572877175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>
                <a:noFill/>
              </a:ln>
              <a:effectLst>
                <a:outerShdw blurRad="317500" algn="ctr" rotWithShape="0">
                  <a:prstClr val="black">
                    <a:alpha val="25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0C88-49BF-BA6A-CBB572877175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>
                <a:noFill/>
              </a:ln>
              <a:effectLst>
                <a:outerShdw blurRad="317500" algn="ctr" rotWithShape="0">
                  <a:prstClr val="black">
                    <a:alpha val="25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0C88-49BF-BA6A-CBB572877175}"/>
              </c:ext>
            </c:extLst>
          </c:dPt>
          <c:dLbls>
            <c:dLbl>
              <c:idx val="0"/>
              <c:layout>
                <c:manualLayout>
                  <c:x val="-0.17015878186129979"/>
                  <c:y val="5.8705560756021118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baseline="0" dirty="0"/>
                      <a:t>
</a:t>
                    </a:r>
                    <a:r>
                      <a:rPr lang="en-US" altLang="zh-CN" baseline="0" dirty="0" smtClean="0"/>
                      <a:t>41-45%</a:t>
                    </a:r>
                    <a:endParaRPr lang="en-US" altLang="zh-CN" dirty="0"/>
                  </a:p>
                </c:rich>
              </c:tx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0C88-49BF-BA6A-CBB572877175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 altLang="zh-CN" baseline="0"/>
                      <a:t>
</a:t>
                    </a:r>
                    <a:r>
                      <a:rPr lang="en-US" altLang="zh-CN" baseline="0" smtClean="0"/>
                      <a:t>15-16%</a:t>
                    </a:r>
                    <a:endParaRPr lang="en-US" altLang="zh-CN" dirty="0"/>
                  </a:p>
                </c:rich>
              </c:tx>
              <c:dLblPos val="in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0C88-49BF-BA6A-CBB572877175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 altLang="zh-CN" baseline="0" smtClean="0"/>
                      <a:t>14-16%</a:t>
                    </a:r>
                    <a:endParaRPr lang="en-US" altLang="zh-CN" dirty="0"/>
                  </a:p>
                </c:rich>
              </c:tx>
              <c:dLblPos val="in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0C88-49BF-BA6A-CBB572877175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 altLang="zh-CN" smtClean="0"/>
                      <a:t>24-26%</a:t>
                    </a:r>
                    <a:endParaRPr lang="en-US" altLang="zh-CN" dirty="0"/>
                  </a:p>
                </c:rich>
              </c:tx>
              <c:dLblPos val="in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0C88-49BF-BA6A-CBB572877175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 altLang="zh-CN" smtClean="0"/>
                      <a:t>2%</a:t>
                    </a:r>
                    <a:endParaRPr lang="en-US" altLang="zh-CN"/>
                  </a:p>
                </c:rich>
              </c:tx>
              <c:dLblPos val="in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0C88-49BF-BA6A-CBB57287717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zh-CN"/>
              </a:p>
            </c:txPr>
            <c:dLblPos val="in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dk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[可变剪切事件统计表2020-05-02.xls]root '!$K$32:$O$32</c:f>
              <c:strCache>
                <c:ptCount val="5"/>
                <c:pt idx="0">
                  <c:v>SE</c:v>
                </c:pt>
                <c:pt idx="1">
                  <c:v>RI</c:v>
                </c:pt>
                <c:pt idx="2">
                  <c:v>A5SS</c:v>
                </c:pt>
                <c:pt idx="3">
                  <c:v>A3SS</c:v>
                </c:pt>
                <c:pt idx="4">
                  <c:v>MXE</c:v>
                </c:pt>
              </c:strCache>
            </c:strRef>
          </c:cat>
          <c:val>
            <c:numRef>
              <c:f>'[可变剪切事件统计表2020-05-02.xls]root '!$K$33:$O$33</c:f>
              <c:numCache>
                <c:formatCode>General</c:formatCode>
                <c:ptCount val="5"/>
                <c:pt idx="0">
                  <c:v>8260.6666666666661</c:v>
                </c:pt>
                <c:pt idx="1">
                  <c:v>3100.6666666666665</c:v>
                </c:pt>
                <c:pt idx="2">
                  <c:v>3105.3333333333335</c:v>
                </c:pt>
                <c:pt idx="3">
                  <c:v>5202</c:v>
                </c:pt>
                <c:pt idx="4">
                  <c:v>304.6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C88-49BF-BA6A-CBB572877175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overlay val="0"/>
      <c:spPr>
        <a:solidFill>
          <a:schemeClr val="lt1">
            <a:alpha val="78000"/>
          </a:schemeClr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 w="9525" cap="flat" cmpd="sng" algn="ctr">
      <a:solidFill>
        <a:sysClr val="window" lastClr="FFFFFF"/>
      </a:solidFill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作图!$D$7</c:f>
              <c:strCache>
                <c:ptCount val="1"/>
                <c:pt idx="0">
                  <c:v>Iso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6:$H$6</c:f>
              <c:strCache>
                <c:ptCount val="4"/>
                <c:pt idx="0">
                  <c:v>MS_WW</c:v>
                </c:pt>
                <c:pt idx="1">
                  <c:v>MS</c:v>
                </c:pt>
                <c:pt idx="2">
                  <c:v>SS_WW</c:v>
                </c:pt>
                <c:pt idx="3">
                  <c:v>SS</c:v>
                </c:pt>
              </c:strCache>
            </c:strRef>
          </c:cat>
          <c:val>
            <c:numRef>
              <c:f>作图!$E$7:$H$7</c:f>
              <c:numCache>
                <c:formatCode>General</c:formatCode>
                <c:ptCount val="4"/>
                <c:pt idx="0">
                  <c:v>0.83233333333299997</c:v>
                </c:pt>
                <c:pt idx="1">
                  <c:v>0.27566666666700002</c:v>
                </c:pt>
                <c:pt idx="2">
                  <c:v>0.74099999999999999</c:v>
                </c:pt>
                <c:pt idx="3">
                  <c:v>0.333333333333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74-4543-ACAF-97868539124E}"/>
            </c:ext>
          </c:extLst>
        </c:ser>
        <c:ser>
          <c:idx val="1"/>
          <c:order val="1"/>
          <c:tx>
            <c:strRef>
              <c:f>作图!$D$8</c:f>
              <c:strCache>
                <c:ptCount val="1"/>
                <c:pt idx="0">
                  <c:v>Iso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6:$H$6</c:f>
              <c:strCache>
                <c:ptCount val="4"/>
                <c:pt idx="0">
                  <c:v>MS_WW</c:v>
                </c:pt>
                <c:pt idx="1">
                  <c:v>MS</c:v>
                </c:pt>
                <c:pt idx="2">
                  <c:v>SS_WW</c:v>
                </c:pt>
                <c:pt idx="3">
                  <c:v>SS</c:v>
                </c:pt>
              </c:strCache>
            </c:strRef>
          </c:cat>
          <c:val>
            <c:numRef>
              <c:f>作图!$E$8:$H$8</c:f>
              <c:numCache>
                <c:formatCode>General</c:formatCode>
                <c:ptCount val="4"/>
                <c:pt idx="0">
                  <c:v>0.16766666666700003</c:v>
                </c:pt>
                <c:pt idx="1">
                  <c:v>0.72433333333299998</c:v>
                </c:pt>
                <c:pt idx="2">
                  <c:v>0.25900000000000001</c:v>
                </c:pt>
                <c:pt idx="3">
                  <c:v>0.666666666667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974-4543-ACAF-97868539124E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834096384"/>
        <c:axId val="1834108032"/>
      </c:barChart>
      <c:catAx>
        <c:axId val="1834096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834108032"/>
        <c:crosses val="autoZero"/>
        <c:auto val="1"/>
        <c:lblAlgn val="ctr"/>
        <c:lblOffset val="100"/>
        <c:noMultiLvlLbl val="0"/>
      </c:catAx>
      <c:valAx>
        <c:axId val="18341080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834096384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作图!$D$2</c:f>
              <c:strCache>
                <c:ptCount val="1"/>
                <c:pt idx="0">
                  <c:v>Iso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作图!$E$1:$J$1</c:f>
              <c:strCache>
                <c:ptCount val="6"/>
                <c:pt idx="0">
                  <c:v>VMS_WW</c:v>
                </c:pt>
                <c:pt idx="1">
                  <c:v>VMS</c:v>
                </c:pt>
                <c:pt idx="2">
                  <c:v>SS_WW</c:v>
                </c:pt>
                <c:pt idx="3">
                  <c:v>SS</c:v>
                </c:pt>
                <c:pt idx="4">
                  <c:v>SR_WW</c:v>
                </c:pt>
                <c:pt idx="5">
                  <c:v>SR</c:v>
                </c:pt>
              </c:strCache>
            </c:strRef>
          </c:cat>
          <c:val>
            <c:numRef>
              <c:f>作图!$E$2:$J$2</c:f>
              <c:numCache>
                <c:formatCode>General</c:formatCode>
                <c:ptCount val="6"/>
                <c:pt idx="0">
                  <c:v>0.48133333333299999</c:v>
                </c:pt>
                <c:pt idx="1">
                  <c:v>0</c:v>
                </c:pt>
                <c:pt idx="2">
                  <c:v>1.96666666667E-2</c:v>
                </c:pt>
                <c:pt idx="3">
                  <c:v>6.66666666667E-2</c:v>
                </c:pt>
                <c:pt idx="4">
                  <c:v>0</c:v>
                </c:pt>
                <c:pt idx="5">
                  <c:v>0.454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D2-4AF2-9AE0-93CC757BABA9}"/>
            </c:ext>
          </c:extLst>
        </c:ser>
        <c:ser>
          <c:idx val="1"/>
          <c:order val="1"/>
          <c:tx>
            <c:strRef>
              <c:f>作图!$D$3</c:f>
              <c:strCache>
                <c:ptCount val="1"/>
                <c:pt idx="0">
                  <c:v>Iso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1:$J$1</c:f>
              <c:strCache>
                <c:ptCount val="6"/>
                <c:pt idx="0">
                  <c:v>VMS_WW</c:v>
                </c:pt>
                <c:pt idx="1">
                  <c:v>VMS</c:v>
                </c:pt>
                <c:pt idx="2">
                  <c:v>SS_WW</c:v>
                </c:pt>
                <c:pt idx="3">
                  <c:v>SS</c:v>
                </c:pt>
                <c:pt idx="4">
                  <c:v>SR_WW</c:v>
                </c:pt>
                <c:pt idx="5">
                  <c:v>SR</c:v>
                </c:pt>
              </c:strCache>
            </c:strRef>
          </c:cat>
          <c:val>
            <c:numRef>
              <c:f>作图!$E$3:$J$3</c:f>
              <c:numCache>
                <c:formatCode>General</c:formatCode>
                <c:ptCount val="6"/>
                <c:pt idx="0">
                  <c:v>0.51866666666700001</c:v>
                </c:pt>
                <c:pt idx="1">
                  <c:v>1</c:v>
                </c:pt>
                <c:pt idx="2">
                  <c:v>0.98033333333329997</c:v>
                </c:pt>
                <c:pt idx="3">
                  <c:v>0.93333333333330004</c:v>
                </c:pt>
                <c:pt idx="4">
                  <c:v>1</c:v>
                </c:pt>
                <c:pt idx="5">
                  <c:v>0.5460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4D2-4AF2-9AE0-93CC757BABA9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545266976"/>
        <c:axId val="1545267392"/>
      </c:barChart>
      <c:catAx>
        <c:axId val="1545266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545267392"/>
        <c:crosses val="autoZero"/>
        <c:auto val="1"/>
        <c:lblAlgn val="ctr"/>
        <c:lblOffset val="100"/>
        <c:noMultiLvlLbl val="0"/>
      </c:catAx>
      <c:valAx>
        <c:axId val="15452673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545266976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作图!$D$26</c:f>
              <c:strCache>
                <c:ptCount val="1"/>
                <c:pt idx="0">
                  <c:v>Iso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25:$J$25</c:f>
              <c:strCache>
                <c:ptCount val="6"/>
                <c:pt idx="0">
                  <c:v>VMS_WW</c:v>
                </c:pt>
                <c:pt idx="1">
                  <c:v>VMS</c:v>
                </c:pt>
                <c:pt idx="2">
                  <c:v>MS_WW</c:v>
                </c:pt>
                <c:pt idx="3">
                  <c:v>MS</c:v>
                </c:pt>
                <c:pt idx="4">
                  <c:v>SR_WW</c:v>
                </c:pt>
                <c:pt idx="5">
                  <c:v>SR</c:v>
                </c:pt>
              </c:strCache>
            </c:strRef>
          </c:cat>
          <c:val>
            <c:numRef>
              <c:f>作图!$E$26:$J$26</c:f>
              <c:numCache>
                <c:formatCode>General</c:formatCode>
                <c:ptCount val="6"/>
                <c:pt idx="0">
                  <c:v>0.8</c:v>
                </c:pt>
                <c:pt idx="1">
                  <c:v>0.5</c:v>
                </c:pt>
                <c:pt idx="2">
                  <c:v>0.56666666666700005</c:v>
                </c:pt>
                <c:pt idx="3">
                  <c:v>0.16033333333300001</c:v>
                </c:pt>
                <c:pt idx="4">
                  <c:v>0.86033333333299999</c:v>
                </c:pt>
                <c:pt idx="5">
                  <c:v>0.105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D9-4CA6-8DDE-51C19F5C6D12}"/>
            </c:ext>
          </c:extLst>
        </c:ser>
        <c:ser>
          <c:idx val="1"/>
          <c:order val="1"/>
          <c:tx>
            <c:strRef>
              <c:f>作图!$D$27</c:f>
              <c:strCache>
                <c:ptCount val="1"/>
                <c:pt idx="0">
                  <c:v>Iso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25:$J$25</c:f>
              <c:strCache>
                <c:ptCount val="6"/>
                <c:pt idx="0">
                  <c:v>VMS_WW</c:v>
                </c:pt>
                <c:pt idx="1">
                  <c:v>VMS</c:v>
                </c:pt>
                <c:pt idx="2">
                  <c:v>MS_WW</c:v>
                </c:pt>
                <c:pt idx="3">
                  <c:v>MS</c:v>
                </c:pt>
                <c:pt idx="4">
                  <c:v>SR_WW</c:v>
                </c:pt>
                <c:pt idx="5">
                  <c:v>SR</c:v>
                </c:pt>
              </c:strCache>
            </c:strRef>
          </c:cat>
          <c:val>
            <c:numRef>
              <c:f>作图!$E$27:$J$27</c:f>
              <c:numCache>
                <c:formatCode>General</c:formatCode>
                <c:ptCount val="6"/>
                <c:pt idx="0">
                  <c:v>0.19999999999999996</c:v>
                </c:pt>
                <c:pt idx="1">
                  <c:v>0.5</c:v>
                </c:pt>
                <c:pt idx="2">
                  <c:v>0.43333333333299995</c:v>
                </c:pt>
                <c:pt idx="3">
                  <c:v>0.83966666666699996</c:v>
                </c:pt>
                <c:pt idx="4">
                  <c:v>0.13966666666700001</c:v>
                </c:pt>
                <c:pt idx="5">
                  <c:v>0.894666666667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ED9-4CA6-8DDE-51C19F5C6D12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123699168"/>
        <c:axId val="1123695008"/>
      </c:barChart>
      <c:catAx>
        <c:axId val="1123699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695008"/>
        <c:crosses val="autoZero"/>
        <c:auto val="1"/>
        <c:lblAlgn val="ctr"/>
        <c:lblOffset val="100"/>
        <c:noMultiLvlLbl val="0"/>
      </c:catAx>
      <c:valAx>
        <c:axId val="11236950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699168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作图!$D$11</c:f>
              <c:strCache>
                <c:ptCount val="1"/>
                <c:pt idx="0">
                  <c:v>Iso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10:$H$10</c:f>
              <c:strCache>
                <c:ptCount val="4"/>
                <c:pt idx="0">
                  <c:v>VMS_WW</c:v>
                </c:pt>
                <c:pt idx="1">
                  <c:v>VMS</c:v>
                </c:pt>
                <c:pt idx="2">
                  <c:v>SS_WW</c:v>
                </c:pt>
                <c:pt idx="3">
                  <c:v>SS</c:v>
                </c:pt>
              </c:strCache>
            </c:strRef>
          </c:cat>
          <c:val>
            <c:numRef>
              <c:f>作图!$E$11:$H$11</c:f>
              <c:numCache>
                <c:formatCode>General</c:formatCode>
                <c:ptCount val="4"/>
                <c:pt idx="0">
                  <c:v>0.12733333333300001</c:v>
                </c:pt>
                <c:pt idx="1">
                  <c:v>0.11066666666699999</c:v>
                </c:pt>
                <c:pt idx="2">
                  <c:v>0.29399999999999998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C1-4485-8725-90CC5D1A40F7}"/>
            </c:ext>
          </c:extLst>
        </c:ser>
        <c:ser>
          <c:idx val="1"/>
          <c:order val="1"/>
          <c:tx>
            <c:strRef>
              <c:f>作图!$D$12</c:f>
              <c:strCache>
                <c:ptCount val="1"/>
                <c:pt idx="0">
                  <c:v>Iso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10:$H$10</c:f>
              <c:strCache>
                <c:ptCount val="4"/>
                <c:pt idx="0">
                  <c:v>VMS_WW</c:v>
                </c:pt>
                <c:pt idx="1">
                  <c:v>VMS</c:v>
                </c:pt>
                <c:pt idx="2">
                  <c:v>SS_WW</c:v>
                </c:pt>
                <c:pt idx="3">
                  <c:v>SS</c:v>
                </c:pt>
              </c:strCache>
            </c:strRef>
          </c:cat>
          <c:val>
            <c:numRef>
              <c:f>作图!$E$12:$H$12</c:f>
              <c:numCache>
                <c:formatCode>General</c:formatCode>
                <c:ptCount val="4"/>
                <c:pt idx="0">
                  <c:v>0.87266666666699999</c:v>
                </c:pt>
                <c:pt idx="1">
                  <c:v>0.88933333333300002</c:v>
                </c:pt>
                <c:pt idx="2">
                  <c:v>0.70599999999999996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2C1-4485-8725-90CC5D1A40F7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123712896"/>
        <c:axId val="1123693760"/>
      </c:barChart>
      <c:catAx>
        <c:axId val="1123712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693760"/>
        <c:crosses val="autoZero"/>
        <c:auto val="1"/>
        <c:lblAlgn val="ctr"/>
        <c:lblOffset val="100"/>
        <c:noMultiLvlLbl val="0"/>
      </c:catAx>
      <c:valAx>
        <c:axId val="11236937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712896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作图!$D$31</c:f>
              <c:strCache>
                <c:ptCount val="1"/>
                <c:pt idx="0">
                  <c:v>Iso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30:$H$30</c:f>
              <c:strCache>
                <c:ptCount val="4"/>
                <c:pt idx="0">
                  <c:v>MS_WW</c:v>
                </c:pt>
                <c:pt idx="1">
                  <c:v>MS</c:v>
                </c:pt>
                <c:pt idx="2">
                  <c:v>SS_WW</c:v>
                </c:pt>
                <c:pt idx="3">
                  <c:v>SS</c:v>
                </c:pt>
              </c:strCache>
            </c:strRef>
          </c:cat>
          <c:val>
            <c:numRef>
              <c:f>作图!$E$31:$H$31</c:f>
              <c:numCache>
                <c:formatCode>General</c:formatCode>
                <c:ptCount val="4"/>
                <c:pt idx="0">
                  <c:v>0.81</c:v>
                </c:pt>
                <c:pt idx="1">
                  <c:v>1</c:v>
                </c:pt>
                <c:pt idx="2">
                  <c:v>0.56899999999999995</c:v>
                </c:pt>
                <c:pt idx="3">
                  <c:v>0.9260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156-4675-8DDE-421257629918}"/>
            </c:ext>
          </c:extLst>
        </c:ser>
        <c:ser>
          <c:idx val="1"/>
          <c:order val="1"/>
          <c:tx>
            <c:strRef>
              <c:f>作图!$D$32</c:f>
              <c:strCache>
                <c:ptCount val="1"/>
                <c:pt idx="0">
                  <c:v>Iso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30:$H$30</c:f>
              <c:strCache>
                <c:ptCount val="4"/>
                <c:pt idx="0">
                  <c:v>MS_WW</c:v>
                </c:pt>
                <c:pt idx="1">
                  <c:v>MS</c:v>
                </c:pt>
                <c:pt idx="2">
                  <c:v>SS_WW</c:v>
                </c:pt>
                <c:pt idx="3">
                  <c:v>SS</c:v>
                </c:pt>
              </c:strCache>
            </c:strRef>
          </c:cat>
          <c:val>
            <c:numRef>
              <c:f>作图!$E$32:$H$32</c:f>
              <c:numCache>
                <c:formatCode>General</c:formatCode>
                <c:ptCount val="4"/>
                <c:pt idx="0">
                  <c:v>0.18999999999999995</c:v>
                </c:pt>
                <c:pt idx="1">
                  <c:v>0</c:v>
                </c:pt>
                <c:pt idx="2">
                  <c:v>0.43100000000000005</c:v>
                </c:pt>
                <c:pt idx="3">
                  <c:v>7.399999999999995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156-4675-8DDE-421257629918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123698336"/>
        <c:axId val="1123714976"/>
      </c:barChart>
      <c:catAx>
        <c:axId val="1123698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714976"/>
        <c:crosses val="autoZero"/>
        <c:auto val="1"/>
        <c:lblAlgn val="ctr"/>
        <c:lblOffset val="100"/>
        <c:noMultiLvlLbl val="0"/>
      </c:catAx>
      <c:valAx>
        <c:axId val="11237149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698336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作图!$D$36</c:f>
              <c:strCache>
                <c:ptCount val="1"/>
                <c:pt idx="0">
                  <c:v>Iso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35:$H$35</c:f>
              <c:strCache>
                <c:ptCount val="4"/>
                <c:pt idx="0">
                  <c:v>VMS_WW</c:v>
                </c:pt>
                <c:pt idx="1">
                  <c:v>VMS</c:v>
                </c:pt>
                <c:pt idx="2">
                  <c:v>MS_WW</c:v>
                </c:pt>
                <c:pt idx="3">
                  <c:v>MS</c:v>
                </c:pt>
              </c:strCache>
            </c:strRef>
          </c:cat>
          <c:val>
            <c:numRef>
              <c:f>作图!$E$36:$H$36</c:f>
              <c:numCache>
                <c:formatCode>General</c:formatCode>
                <c:ptCount val="4"/>
                <c:pt idx="0">
                  <c:v>4.7666666666699997E-2</c:v>
                </c:pt>
                <c:pt idx="1">
                  <c:v>0.15166666666699999</c:v>
                </c:pt>
                <c:pt idx="2">
                  <c:v>0.24266666666700001</c:v>
                </c:pt>
                <c:pt idx="3">
                  <c:v>3.36666666666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3AD-4857-B510-E79AA842248F}"/>
            </c:ext>
          </c:extLst>
        </c:ser>
        <c:ser>
          <c:idx val="1"/>
          <c:order val="1"/>
          <c:tx>
            <c:strRef>
              <c:f>作图!$D$37</c:f>
              <c:strCache>
                <c:ptCount val="1"/>
                <c:pt idx="0">
                  <c:v>Iso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35:$H$35</c:f>
              <c:strCache>
                <c:ptCount val="4"/>
                <c:pt idx="0">
                  <c:v>VMS_WW</c:v>
                </c:pt>
                <c:pt idx="1">
                  <c:v>VMS</c:v>
                </c:pt>
                <c:pt idx="2">
                  <c:v>MS_WW</c:v>
                </c:pt>
                <c:pt idx="3">
                  <c:v>MS</c:v>
                </c:pt>
              </c:strCache>
            </c:strRef>
          </c:cat>
          <c:val>
            <c:numRef>
              <c:f>作图!$E$37:$H$37</c:f>
              <c:numCache>
                <c:formatCode>General</c:formatCode>
                <c:ptCount val="4"/>
                <c:pt idx="0">
                  <c:v>0.95233333333329995</c:v>
                </c:pt>
                <c:pt idx="1">
                  <c:v>0.84833333333299998</c:v>
                </c:pt>
                <c:pt idx="2">
                  <c:v>0.75733333333300001</c:v>
                </c:pt>
                <c:pt idx="3">
                  <c:v>0.9663333333332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3AD-4857-B510-E79AA84224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123707072"/>
        <c:axId val="1123692928"/>
      </c:barChart>
      <c:catAx>
        <c:axId val="1123707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692928"/>
        <c:crosses val="autoZero"/>
        <c:auto val="1"/>
        <c:lblAlgn val="ctr"/>
        <c:lblOffset val="100"/>
        <c:noMultiLvlLbl val="0"/>
      </c:catAx>
      <c:valAx>
        <c:axId val="11236929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707072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作图!$D$41</c:f>
              <c:strCache>
                <c:ptCount val="1"/>
                <c:pt idx="0">
                  <c:v>Iso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40:$H$40</c:f>
              <c:strCache>
                <c:ptCount val="4"/>
                <c:pt idx="0">
                  <c:v>MS_WW</c:v>
                </c:pt>
                <c:pt idx="1">
                  <c:v>MS</c:v>
                </c:pt>
                <c:pt idx="2">
                  <c:v>SS_WW</c:v>
                </c:pt>
                <c:pt idx="3">
                  <c:v>SS</c:v>
                </c:pt>
              </c:strCache>
            </c:strRef>
          </c:cat>
          <c:val>
            <c:numRef>
              <c:f>作图!$E$41:$H$41</c:f>
              <c:numCache>
                <c:formatCode>General</c:formatCode>
                <c:ptCount val="4"/>
                <c:pt idx="0">
                  <c:v>3.3333333333299998E-2</c:v>
                </c:pt>
                <c:pt idx="1">
                  <c:v>0.40400000000000003</c:v>
                </c:pt>
                <c:pt idx="2">
                  <c:v>1</c:v>
                </c:pt>
                <c:pt idx="3">
                  <c:v>0.454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8D-4A9E-8400-6B19743EC7F3}"/>
            </c:ext>
          </c:extLst>
        </c:ser>
        <c:ser>
          <c:idx val="1"/>
          <c:order val="1"/>
          <c:tx>
            <c:strRef>
              <c:f>作图!$D$42</c:f>
              <c:strCache>
                <c:ptCount val="1"/>
                <c:pt idx="0">
                  <c:v>Iso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40:$H$40</c:f>
              <c:strCache>
                <c:ptCount val="4"/>
                <c:pt idx="0">
                  <c:v>MS_WW</c:v>
                </c:pt>
                <c:pt idx="1">
                  <c:v>MS</c:v>
                </c:pt>
                <c:pt idx="2">
                  <c:v>SS_WW</c:v>
                </c:pt>
                <c:pt idx="3">
                  <c:v>SS</c:v>
                </c:pt>
              </c:strCache>
            </c:strRef>
          </c:cat>
          <c:val>
            <c:numRef>
              <c:f>作图!$E$42:$H$42</c:f>
              <c:numCache>
                <c:formatCode>General</c:formatCode>
                <c:ptCount val="4"/>
                <c:pt idx="0">
                  <c:v>0.96666666666669998</c:v>
                </c:pt>
                <c:pt idx="1">
                  <c:v>0.59599999999999997</c:v>
                </c:pt>
                <c:pt idx="2">
                  <c:v>0</c:v>
                </c:pt>
                <c:pt idx="3">
                  <c:v>0.5460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88D-4A9E-8400-6B19743EC7F3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123695424"/>
        <c:axId val="1123705408"/>
      </c:barChart>
      <c:catAx>
        <c:axId val="1123695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705408"/>
        <c:crosses val="autoZero"/>
        <c:auto val="1"/>
        <c:lblAlgn val="ctr"/>
        <c:lblOffset val="100"/>
        <c:noMultiLvlLbl val="0"/>
      </c:catAx>
      <c:valAx>
        <c:axId val="11237054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695424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作图!$D$46</c:f>
              <c:strCache>
                <c:ptCount val="1"/>
                <c:pt idx="0">
                  <c:v>Iso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45:$H$45</c:f>
              <c:strCache>
                <c:ptCount val="4"/>
                <c:pt idx="0">
                  <c:v>VMS_WW</c:v>
                </c:pt>
                <c:pt idx="1">
                  <c:v>VMS</c:v>
                </c:pt>
                <c:pt idx="2">
                  <c:v>SR_WW</c:v>
                </c:pt>
                <c:pt idx="3">
                  <c:v>SR</c:v>
                </c:pt>
              </c:strCache>
            </c:strRef>
          </c:cat>
          <c:val>
            <c:numRef>
              <c:f>作图!$E$46:$H$46</c:f>
              <c:numCache>
                <c:formatCode>General</c:formatCode>
                <c:ptCount val="4"/>
                <c:pt idx="0">
                  <c:v>0.95833333333299997</c:v>
                </c:pt>
                <c:pt idx="1">
                  <c:v>0.67800000000000005</c:v>
                </c:pt>
                <c:pt idx="2">
                  <c:v>0.60066666666699997</c:v>
                </c:pt>
                <c:pt idx="3">
                  <c:v>0.958333333332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D5-433E-A4BC-3CDD6359C907}"/>
            </c:ext>
          </c:extLst>
        </c:ser>
        <c:ser>
          <c:idx val="1"/>
          <c:order val="1"/>
          <c:tx>
            <c:strRef>
              <c:f>作图!$D$47</c:f>
              <c:strCache>
                <c:ptCount val="1"/>
                <c:pt idx="0">
                  <c:v>Iso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45:$H$45</c:f>
              <c:strCache>
                <c:ptCount val="4"/>
                <c:pt idx="0">
                  <c:v>VMS_WW</c:v>
                </c:pt>
                <c:pt idx="1">
                  <c:v>VMS</c:v>
                </c:pt>
                <c:pt idx="2">
                  <c:v>SR_WW</c:v>
                </c:pt>
                <c:pt idx="3">
                  <c:v>SR</c:v>
                </c:pt>
              </c:strCache>
            </c:strRef>
          </c:cat>
          <c:val>
            <c:numRef>
              <c:f>作图!$E$47:$H$47</c:f>
              <c:numCache>
                <c:formatCode>General</c:formatCode>
                <c:ptCount val="4"/>
                <c:pt idx="0">
                  <c:v>4.166666666700003E-2</c:v>
                </c:pt>
                <c:pt idx="1">
                  <c:v>0.32199999999999995</c:v>
                </c:pt>
                <c:pt idx="2">
                  <c:v>0.39933333333300003</c:v>
                </c:pt>
                <c:pt idx="3">
                  <c:v>4.1666666667000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FD5-433E-A4BC-3CDD6359C907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123700416"/>
        <c:axId val="1123709152"/>
      </c:barChart>
      <c:catAx>
        <c:axId val="1123700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709152"/>
        <c:crosses val="autoZero"/>
        <c:auto val="1"/>
        <c:lblAlgn val="ctr"/>
        <c:lblOffset val="100"/>
        <c:noMultiLvlLbl val="0"/>
      </c:catAx>
      <c:valAx>
        <c:axId val="11237091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700416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作图!$D$51</c:f>
              <c:strCache>
                <c:ptCount val="1"/>
                <c:pt idx="0">
                  <c:v>Iso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50:$H$50</c:f>
              <c:strCache>
                <c:ptCount val="4"/>
                <c:pt idx="0">
                  <c:v>SS_WW</c:v>
                </c:pt>
                <c:pt idx="1">
                  <c:v>SS</c:v>
                </c:pt>
                <c:pt idx="2">
                  <c:v>SR_WW</c:v>
                </c:pt>
                <c:pt idx="3">
                  <c:v>SR</c:v>
                </c:pt>
              </c:strCache>
            </c:strRef>
          </c:cat>
          <c:val>
            <c:numRef>
              <c:f>作图!$E$51:$H$51</c:f>
              <c:numCache>
                <c:formatCode>General</c:formatCode>
                <c:ptCount val="4"/>
                <c:pt idx="0">
                  <c:v>6.2333333333300003E-2</c:v>
                </c:pt>
                <c:pt idx="1">
                  <c:v>0.38700000000000001</c:v>
                </c:pt>
                <c:pt idx="2">
                  <c:v>6.2333333333300003E-2</c:v>
                </c:pt>
                <c:pt idx="3">
                  <c:v>0.510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9C-448D-9B99-6A194FDB4A02}"/>
            </c:ext>
          </c:extLst>
        </c:ser>
        <c:ser>
          <c:idx val="1"/>
          <c:order val="1"/>
          <c:tx>
            <c:strRef>
              <c:f>作图!$D$52</c:f>
              <c:strCache>
                <c:ptCount val="1"/>
                <c:pt idx="0">
                  <c:v>Iso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50:$H$50</c:f>
              <c:strCache>
                <c:ptCount val="4"/>
                <c:pt idx="0">
                  <c:v>SS_WW</c:v>
                </c:pt>
                <c:pt idx="1">
                  <c:v>SS</c:v>
                </c:pt>
                <c:pt idx="2">
                  <c:v>SR_WW</c:v>
                </c:pt>
                <c:pt idx="3">
                  <c:v>SR</c:v>
                </c:pt>
              </c:strCache>
            </c:strRef>
          </c:cat>
          <c:val>
            <c:numRef>
              <c:f>作图!$E$52:$H$52</c:f>
              <c:numCache>
                <c:formatCode>General</c:formatCode>
                <c:ptCount val="4"/>
                <c:pt idx="0">
                  <c:v>0.93766666666669996</c:v>
                </c:pt>
                <c:pt idx="1">
                  <c:v>0.61299999999999999</c:v>
                </c:pt>
                <c:pt idx="2">
                  <c:v>0.93766666666669996</c:v>
                </c:pt>
                <c:pt idx="3">
                  <c:v>0.489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29C-448D-9B99-6A194FDB4A02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123704160"/>
        <c:axId val="1123711232"/>
      </c:barChart>
      <c:catAx>
        <c:axId val="1123704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711232"/>
        <c:crosses val="autoZero"/>
        <c:auto val="1"/>
        <c:lblAlgn val="ctr"/>
        <c:lblOffset val="100"/>
        <c:noMultiLvlLbl val="0"/>
      </c:catAx>
      <c:valAx>
        <c:axId val="11237112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704160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作图!$D$56</c:f>
              <c:strCache>
                <c:ptCount val="1"/>
                <c:pt idx="0">
                  <c:v>Iso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55:$H$55</c:f>
              <c:strCache>
                <c:ptCount val="4"/>
                <c:pt idx="0">
                  <c:v>MS_WW</c:v>
                </c:pt>
                <c:pt idx="1">
                  <c:v>MS</c:v>
                </c:pt>
                <c:pt idx="2">
                  <c:v>SS_WW</c:v>
                </c:pt>
                <c:pt idx="3">
                  <c:v>SS</c:v>
                </c:pt>
              </c:strCache>
            </c:strRef>
          </c:cat>
          <c:val>
            <c:numRef>
              <c:f>作图!$E$56:$H$56</c:f>
              <c:numCache>
                <c:formatCode>General</c:formatCode>
                <c:ptCount val="4"/>
                <c:pt idx="0">
                  <c:v>0.14766666666700001</c:v>
                </c:pt>
                <c:pt idx="1">
                  <c:v>2.9666666666699999E-2</c:v>
                </c:pt>
                <c:pt idx="2">
                  <c:v>0.26933333333300002</c:v>
                </c:pt>
                <c:pt idx="3">
                  <c:v>7.299999999999999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DB-4855-B5AF-FA8B563E802F}"/>
            </c:ext>
          </c:extLst>
        </c:ser>
        <c:ser>
          <c:idx val="1"/>
          <c:order val="1"/>
          <c:tx>
            <c:strRef>
              <c:f>作图!$D$57</c:f>
              <c:strCache>
                <c:ptCount val="1"/>
                <c:pt idx="0">
                  <c:v>Iso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55:$H$55</c:f>
              <c:strCache>
                <c:ptCount val="4"/>
                <c:pt idx="0">
                  <c:v>MS_WW</c:v>
                </c:pt>
                <c:pt idx="1">
                  <c:v>MS</c:v>
                </c:pt>
                <c:pt idx="2">
                  <c:v>SS_WW</c:v>
                </c:pt>
                <c:pt idx="3">
                  <c:v>SS</c:v>
                </c:pt>
              </c:strCache>
            </c:strRef>
          </c:cat>
          <c:val>
            <c:numRef>
              <c:f>作图!$E$57:$H$57</c:f>
              <c:numCache>
                <c:formatCode>General</c:formatCode>
                <c:ptCount val="4"/>
                <c:pt idx="0">
                  <c:v>0.85233333333299999</c:v>
                </c:pt>
                <c:pt idx="1">
                  <c:v>0.97033333333329996</c:v>
                </c:pt>
                <c:pt idx="2">
                  <c:v>0.73066666666699998</c:v>
                </c:pt>
                <c:pt idx="3">
                  <c:v>0.9270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1DB-4855-B5AF-FA8B563E802F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649336608"/>
        <c:axId val="1649333696"/>
      </c:barChart>
      <c:catAx>
        <c:axId val="1649336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649333696"/>
        <c:crosses val="autoZero"/>
        <c:auto val="1"/>
        <c:lblAlgn val="ctr"/>
        <c:lblOffset val="100"/>
        <c:noMultiLvlLbl val="0"/>
      </c:catAx>
      <c:valAx>
        <c:axId val="16493336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649336608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作图!$D$21</c:f>
              <c:strCache>
                <c:ptCount val="1"/>
                <c:pt idx="0">
                  <c:v>Iso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20:$H$20</c:f>
              <c:strCache>
                <c:ptCount val="4"/>
                <c:pt idx="0">
                  <c:v>VMS_WW</c:v>
                </c:pt>
                <c:pt idx="1">
                  <c:v>VMS</c:v>
                </c:pt>
                <c:pt idx="2">
                  <c:v>SR_WW</c:v>
                </c:pt>
                <c:pt idx="3">
                  <c:v>SR</c:v>
                </c:pt>
              </c:strCache>
            </c:strRef>
          </c:cat>
          <c:val>
            <c:numRef>
              <c:f>作图!$E$21:$H$21</c:f>
              <c:numCache>
                <c:formatCode>General</c:formatCode>
                <c:ptCount val="4"/>
                <c:pt idx="0">
                  <c:v>0.50700000000000001</c:v>
                </c:pt>
                <c:pt idx="1">
                  <c:v>1</c:v>
                </c:pt>
                <c:pt idx="2">
                  <c:v>1</c:v>
                </c:pt>
                <c:pt idx="3">
                  <c:v>0.646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3C-4D6A-8DFD-15278E2AB58D}"/>
            </c:ext>
          </c:extLst>
        </c:ser>
        <c:ser>
          <c:idx val="1"/>
          <c:order val="1"/>
          <c:tx>
            <c:strRef>
              <c:f>作图!$D$22</c:f>
              <c:strCache>
                <c:ptCount val="1"/>
                <c:pt idx="0">
                  <c:v>Iso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作图!$E$20:$H$20</c:f>
              <c:strCache>
                <c:ptCount val="4"/>
                <c:pt idx="0">
                  <c:v>VMS_WW</c:v>
                </c:pt>
                <c:pt idx="1">
                  <c:v>VMS</c:v>
                </c:pt>
                <c:pt idx="2">
                  <c:v>SR_WW</c:v>
                </c:pt>
                <c:pt idx="3">
                  <c:v>SR</c:v>
                </c:pt>
              </c:strCache>
            </c:strRef>
          </c:cat>
          <c:val>
            <c:numRef>
              <c:f>作图!$E$22:$H$22</c:f>
              <c:numCache>
                <c:formatCode>General</c:formatCode>
                <c:ptCount val="4"/>
                <c:pt idx="0">
                  <c:v>0.49299999999999999</c:v>
                </c:pt>
                <c:pt idx="1">
                  <c:v>0</c:v>
                </c:pt>
                <c:pt idx="2">
                  <c:v>0</c:v>
                </c:pt>
                <c:pt idx="3">
                  <c:v>0.353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F3C-4D6A-8DFD-15278E2AB58D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1123707488"/>
        <c:axId val="1123713312"/>
      </c:barChart>
      <c:catAx>
        <c:axId val="11237074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713312"/>
        <c:crosses val="autoZero"/>
        <c:auto val="1"/>
        <c:lblAlgn val="ctr"/>
        <c:lblOffset val="100"/>
        <c:noMultiLvlLbl val="0"/>
      </c:catAx>
      <c:valAx>
        <c:axId val="11237133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123707488"/>
        <c:crosses val="autoZero"/>
        <c:crossBetween val="between"/>
        <c:maj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8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61">
  <cs:axisTitle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categoryAxis>
  <cs:chartArea>
    <cs:lnRef idx="0"/>
    <cs:fillRef idx="0"/>
    <cs:effectRef idx="0"/>
    <cs:fontRef idx="minor">
      <a:schemeClr val="dk1"/>
    </cs:fontRef>
    <cs:spPr>
      <a:pattFill prst="dkDnDiag">
        <a:fgClr>
          <a:schemeClr val="lt1">
            <a:lumMod val="95000"/>
          </a:schemeClr>
        </a:fgClr>
        <a:bgClr>
          <a:schemeClr val="lt1"/>
        </a:bgClr>
      </a:patt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>
          <a:alpha val="75000"/>
        </a:schemeClr>
      </a:solidFill>
      <a:ln w="9525"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317500" algn="ctr" rotWithShape="0">
          <a:prstClr val="black">
            <a:alpha val="25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20000"/>
          </a:prstClr>
        </a:outerShdw>
      </a:effectLst>
      <a:scene3d>
        <a:camera prst="orthographicFront"/>
        <a:lightRig rig="threePt" dir="t"/>
      </a:scene3d>
      <a:sp3d prstMaterial="matte"/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noFill/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>
          <a:alpha val="78000"/>
        </a:schemeClr>
      </a:solidFill>
    </cs:spPr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65000"/>
        <a:lumOff val="3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10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FB1271-1BD5-4475-AB14-D52D041B03FA}" type="datetimeFigureOut">
              <a:rPr lang="zh-CN" altLang="en-US" smtClean="0"/>
              <a:t>2020-12-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65AD24-9E7F-4D70-930D-A7DA61FC059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07831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EA428-FCED-4651-A15D-95060B2B9D65}" type="datetimeFigureOut">
              <a:rPr lang="zh-CN" altLang="en-US" smtClean="0"/>
              <a:t>2020-12-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2C89C-CBEB-403A-85EC-647087759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999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EA428-FCED-4651-A15D-95060B2B9D65}" type="datetimeFigureOut">
              <a:rPr lang="zh-CN" altLang="en-US" smtClean="0"/>
              <a:t>2020-12-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2C89C-CBEB-403A-85EC-647087759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0126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EA428-FCED-4651-A15D-95060B2B9D65}" type="datetimeFigureOut">
              <a:rPr lang="zh-CN" altLang="en-US" smtClean="0"/>
              <a:t>2020-12-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2C89C-CBEB-403A-85EC-647087759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2262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EA428-FCED-4651-A15D-95060B2B9D65}" type="datetimeFigureOut">
              <a:rPr lang="zh-CN" altLang="en-US" smtClean="0"/>
              <a:t>2020-12-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2C89C-CBEB-403A-85EC-647087759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9517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EA428-FCED-4651-A15D-95060B2B9D65}" type="datetimeFigureOut">
              <a:rPr lang="zh-CN" altLang="en-US" smtClean="0"/>
              <a:t>2020-12-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2C89C-CBEB-403A-85EC-647087759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101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EA428-FCED-4651-A15D-95060B2B9D65}" type="datetimeFigureOut">
              <a:rPr lang="zh-CN" altLang="en-US" smtClean="0"/>
              <a:t>2020-12-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2C89C-CBEB-403A-85EC-647087759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10419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EA428-FCED-4651-A15D-95060B2B9D65}" type="datetimeFigureOut">
              <a:rPr lang="zh-CN" altLang="en-US" smtClean="0"/>
              <a:t>2020-12-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2C89C-CBEB-403A-85EC-647087759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36613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EA428-FCED-4651-A15D-95060B2B9D65}" type="datetimeFigureOut">
              <a:rPr lang="zh-CN" altLang="en-US" smtClean="0"/>
              <a:t>2020-12-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2C89C-CBEB-403A-85EC-647087759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9283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EA428-FCED-4651-A15D-95060B2B9D65}" type="datetimeFigureOut">
              <a:rPr lang="zh-CN" altLang="en-US" smtClean="0"/>
              <a:t>2020-12-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2C89C-CBEB-403A-85EC-647087759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981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EA428-FCED-4651-A15D-95060B2B9D65}" type="datetimeFigureOut">
              <a:rPr lang="zh-CN" altLang="en-US" smtClean="0"/>
              <a:t>2020-12-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2C89C-CBEB-403A-85EC-647087759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1008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4EA428-FCED-4651-A15D-95060B2B9D65}" type="datetimeFigureOut">
              <a:rPr lang="zh-CN" altLang="en-US" smtClean="0"/>
              <a:t>2020-12-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62C89C-CBEB-403A-85EC-647087759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2976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4EA428-FCED-4651-A15D-95060B2B9D65}" type="datetimeFigureOut">
              <a:rPr lang="zh-CN" altLang="en-US" smtClean="0"/>
              <a:t>2020-12-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62C89C-CBEB-403A-85EC-647087759B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199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8.xml"/><Relationship Id="rId3" Type="http://schemas.openxmlformats.org/officeDocument/2006/relationships/chart" Target="../charts/chart3.xml"/><Relationship Id="rId7" Type="http://schemas.openxmlformats.org/officeDocument/2006/relationships/chart" Target="../charts/chart7.xml"/><Relationship Id="rId12" Type="http://schemas.openxmlformats.org/officeDocument/2006/relationships/chart" Target="../charts/chart12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6.xml"/><Relationship Id="rId11" Type="http://schemas.openxmlformats.org/officeDocument/2006/relationships/chart" Target="../charts/chart11.xml"/><Relationship Id="rId5" Type="http://schemas.openxmlformats.org/officeDocument/2006/relationships/chart" Target="../charts/chart5.xml"/><Relationship Id="rId10" Type="http://schemas.openxmlformats.org/officeDocument/2006/relationships/chart" Target="../charts/chart10.xml"/><Relationship Id="rId4" Type="http://schemas.openxmlformats.org/officeDocument/2006/relationships/chart" Target="../charts/chart4.xml"/><Relationship Id="rId9" Type="http://schemas.openxmlformats.org/officeDocument/2006/relationships/chart" Target="../charts/chart9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5339870" y="734549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875443" y="1382863"/>
            <a:ext cx="4824297" cy="6018255"/>
            <a:chOff x="875443" y="1382863"/>
            <a:chExt cx="4824297" cy="6018255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70717" y="1382863"/>
              <a:ext cx="4529023" cy="283098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70717" y="4542704"/>
              <a:ext cx="4529023" cy="28584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文本框 5"/>
            <p:cNvSpPr txBox="1"/>
            <p:nvPr/>
          </p:nvSpPr>
          <p:spPr>
            <a:xfrm>
              <a:off x="875443" y="1382863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875443" y="4542704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051264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图表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3256354"/>
              </p:ext>
            </p:extLst>
          </p:nvPr>
        </p:nvGraphicFramePr>
        <p:xfrm>
          <a:off x="1232340" y="1686002"/>
          <a:ext cx="3106904" cy="26781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4" name="文本框 13"/>
          <p:cNvSpPr txBox="1"/>
          <p:nvPr/>
        </p:nvSpPr>
        <p:spPr>
          <a:xfrm>
            <a:off x="5339870" y="734549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41761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5339870" y="734549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592159" y="1379047"/>
            <a:ext cx="5625644" cy="7261888"/>
            <a:chOff x="592159" y="1379047"/>
            <a:chExt cx="5625644" cy="7261888"/>
          </a:xfrm>
        </p:grpSpPr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2159" y="6202535"/>
              <a:ext cx="2438400" cy="2438400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2159" y="3680399"/>
              <a:ext cx="2438400" cy="2438400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79403" y="3680399"/>
              <a:ext cx="2438400" cy="2438400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8096" y="1432917"/>
              <a:ext cx="2438400" cy="2438400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7536" y="1432917"/>
              <a:ext cx="2438400" cy="2438400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1593001" y="3470086"/>
              <a:ext cx="372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4653262" y="3470086"/>
              <a:ext cx="5421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3SS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508042" y="5717568"/>
              <a:ext cx="5421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5SS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4747038" y="571756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I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1507241" y="8256004"/>
              <a:ext cx="5437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XE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774724" y="1379047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3624575" y="1432917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627087" y="3940868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720046" y="630184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3615958" y="400943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667889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文本框 30"/>
          <p:cNvSpPr txBox="1"/>
          <p:nvPr/>
        </p:nvSpPr>
        <p:spPr>
          <a:xfrm>
            <a:off x="5363020" y="270232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457419" y="635742"/>
            <a:ext cx="5961518" cy="8021639"/>
            <a:chOff x="457419" y="635742"/>
            <a:chExt cx="5961518" cy="8021639"/>
          </a:xfrm>
        </p:grpSpPr>
        <p:graphicFrame>
          <p:nvGraphicFramePr>
            <p:cNvPr id="2" name="图表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82090023"/>
                </p:ext>
              </p:extLst>
            </p:nvPr>
          </p:nvGraphicFramePr>
          <p:xfrm>
            <a:off x="2430392" y="6836787"/>
            <a:ext cx="1962000" cy="153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图表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34447255"/>
                </p:ext>
              </p:extLst>
            </p:nvPr>
          </p:nvGraphicFramePr>
          <p:xfrm>
            <a:off x="2430392" y="4928361"/>
            <a:ext cx="1962000" cy="153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图表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36922897"/>
                </p:ext>
              </p:extLst>
            </p:nvPr>
          </p:nvGraphicFramePr>
          <p:xfrm>
            <a:off x="460700" y="4928361"/>
            <a:ext cx="1962000" cy="153066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图表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70980598"/>
                </p:ext>
              </p:extLst>
            </p:nvPr>
          </p:nvGraphicFramePr>
          <p:xfrm>
            <a:off x="4400084" y="2906297"/>
            <a:ext cx="1962000" cy="153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8" name="图表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38849364"/>
                </p:ext>
              </p:extLst>
            </p:nvPr>
          </p:nvGraphicFramePr>
          <p:xfrm>
            <a:off x="2430392" y="2906297"/>
            <a:ext cx="1962000" cy="153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9" name="图表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42164866"/>
                </p:ext>
              </p:extLst>
            </p:nvPr>
          </p:nvGraphicFramePr>
          <p:xfrm>
            <a:off x="4400084" y="4928361"/>
            <a:ext cx="1962000" cy="153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10" name="图表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30086484"/>
                </p:ext>
              </p:extLst>
            </p:nvPr>
          </p:nvGraphicFramePr>
          <p:xfrm>
            <a:off x="4400084" y="6836787"/>
            <a:ext cx="1962000" cy="153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11" name="图表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31294842"/>
                </p:ext>
              </p:extLst>
            </p:nvPr>
          </p:nvGraphicFramePr>
          <p:xfrm>
            <a:off x="457419" y="2906297"/>
            <a:ext cx="1962000" cy="153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2" name="图表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71519350"/>
                </p:ext>
              </p:extLst>
            </p:nvPr>
          </p:nvGraphicFramePr>
          <p:xfrm>
            <a:off x="460700" y="6836787"/>
            <a:ext cx="1962000" cy="153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13" name="矩形 12"/>
            <p:cNvSpPr/>
            <p:nvPr/>
          </p:nvSpPr>
          <p:spPr>
            <a:xfrm>
              <a:off x="631434" y="4458333"/>
              <a:ext cx="1595309" cy="5078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ma.06G324000</a:t>
              </a: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2 </a:t>
              </a:r>
              <a:r>
                <a:rPr lang="en-US" altLang="zh-CN" sz="9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nRNP</a:t>
              </a:r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9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uxilliary</a:t>
              </a:r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actor, </a:t>
              </a:r>
              <a:endPara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rge </a:t>
              </a:r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bunit</a:t>
              </a:r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splicing </a:t>
              </a:r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</a:t>
              </a:r>
            </a:p>
          </p:txBody>
        </p:sp>
        <p:sp>
          <p:nvSpPr>
            <p:cNvPr id="14" name="矩形 13"/>
            <p:cNvSpPr/>
            <p:nvPr/>
          </p:nvSpPr>
          <p:spPr>
            <a:xfrm>
              <a:off x="462627" y="2582070"/>
              <a:ext cx="190308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ma.20G014300</a:t>
              </a: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uxin efflux carrier family protein</a:t>
              </a:r>
            </a:p>
          </p:txBody>
        </p:sp>
        <p:sp>
          <p:nvSpPr>
            <p:cNvPr id="15" name="矩形 14"/>
            <p:cNvSpPr/>
            <p:nvPr/>
          </p:nvSpPr>
          <p:spPr>
            <a:xfrm>
              <a:off x="4422376" y="2582070"/>
              <a:ext cx="190308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ma.19G128800</a:t>
              </a: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uxin efflux carrier family protein</a:t>
              </a:r>
            </a:p>
          </p:txBody>
        </p:sp>
        <p:sp>
          <p:nvSpPr>
            <p:cNvPr id="16" name="矩形 15"/>
            <p:cNvSpPr/>
            <p:nvPr/>
          </p:nvSpPr>
          <p:spPr>
            <a:xfrm>
              <a:off x="2545684" y="6495365"/>
              <a:ext cx="177484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ma.14G178800</a:t>
              </a: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NAJ heat shock family protein</a:t>
              </a:r>
            </a:p>
          </p:txBody>
        </p:sp>
        <p:sp>
          <p:nvSpPr>
            <p:cNvPr id="17" name="矩形 16"/>
            <p:cNvSpPr/>
            <p:nvPr/>
          </p:nvSpPr>
          <p:spPr>
            <a:xfrm>
              <a:off x="2609677" y="4458333"/>
              <a:ext cx="1646605" cy="5078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ma.13G200800</a:t>
              </a: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NAJ heat shock N-terminal </a:t>
              </a:r>
              <a:endPara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main -</a:t>
              </a:r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aining protein</a:t>
              </a:r>
            </a:p>
          </p:txBody>
        </p:sp>
        <p:sp>
          <p:nvSpPr>
            <p:cNvPr id="18" name="矩形 17"/>
            <p:cNvSpPr/>
            <p:nvPr/>
          </p:nvSpPr>
          <p:spPr>
            <a:xfrm>
              <a:off x="4382867" y="6495365"/>
              <a:ext cx="203453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ma.10G239100</a:t>
              </a: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ginine/serine-rich splicing factor 35</a:t>
              </a:r>
            </a:p>
          </p:txBody>
        </p:sp>
        <p:sp>
          <p:nvSpPr>
            <p:cNvPr id="19" name="矩形 18"/>
            <p:cNvSpPr/>
            <p:nvPr/>
          </p:nvSpPr>
          <p:spPr>
            <a:xfrm>
              <a:off x="761953" y="6495365"/>
              <a:ext cx="132921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ma.12G071000</a:t>
              </a: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uxin response factor 4</a:t>
              </a:r>
            </a:p>
          </p:txBody>
        </p:sp>
        <p:sp>
          <p:nvSpPr>
            <p:cNvPr id="20" name="矩形 19"/>
            <p:cNvSpPr/>
            <p:nvPr/>
          </p:nvSpPr>
          <p:spPr>
            <a:xfrm>
              <a:off x="2446281" y="2582070"/>
              <a:ext cx="190308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ma.19G128800</a:t>
              </a: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uxin efflux carrier family protein</a:t>
              </a:r>
            </a:p>
          </p:txBody>
        </p:sp>
        <p:sp>
          <p:nvSpPr>
            <p:cNvPr id="21" name="矩形 20"/>
            <p:cNvSpPr/>
            <p:nvPr/>
          </p:nvSpPr>
          <p:spPr>
            <a:xfrm>
              <a:off x="4620566" y="4458333"/>
              <a:ext cx="1646606" cy="5078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ma.06G126400</a:t>
              </a: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NAJ heat shock N-terminal </a:t>
              </a:r>
              <a:endPara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omain -</a:t>
              </a:r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aining protein</a:t>
              </a:r>
            </a:p>
          </p:txBody>
        </p:sp>
        <p:graphicFrame>
          <p:nvGraphicFramePr>
            <p:cNvPr id="22" name="图表 2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07229476"/>
                </p:ext>
              </p:extLst>
            </p:nvPr>
          </p:nvGraphicFramePr>
          <p:xfrm>
            <a:off x="457419" y="971978"/>
            <a:ext cx="2934000" cy="153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graphicFrame>
          <p:nvGraphicFramePr>
            <p:cNvPr id="23" name="图表 2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62024190"/>
                </p:ext>
              </p:extLst>
            </p:nvPr>
          </p:nvGraphicFramePr>
          <p:xfrm>
            <a:off x="3428084" y="971978"/>
            <a:ext cx="2934000" cy="153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24" name="矩形 23"/>
            <p:cNvSpPr/>
            <p:nvPr/>
          </p:nvSpPr>
          <p:spPr>
            <a:xfrm>
              <a:off x="1463629" y="635742"/>
              <a:ext cx="115608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ma.05G041800</a:t>
              </a:r>
            </a:p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rought-induced 19</a:t>
              </a:r>
            </a:p>
          </p:txBody>
        </p:sp>
        <p:sp>
          <p:nvSpPr>
            <p:cNvPr id="25" name="矩形 24"/>
            <p:cNvSpPr/>
            <p:nvPr/>
          </p:nvSpPr>
          <p:spPr>
            <a:xfrm>
              <a:off x="3783401" y="635742"/>
              <a:ext cx="217559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ma.02G057600</a:t>
              </a: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1 small nuclear ribonucleoprotein-70K</a:t>
              </a:r>
            </a:p>
          </p:txBody>
        </p:sp>
        <p:sp>
          <p:nvSpPr>
            <p:cNvPr id="27" name="矩形 26"/>
            <p:cNvSpPr/>
            <p:nvPr/>
          </p:nvSpPr>
          <p:spPr>
            <a:xfrm>
              <a:off x="3425073" y="8487965"/>
              <a:ext cx="108000" cy="108000"/>
            </a:xfrm>
            <a:prstGeom prst="rect">
              <a:avLst/>
            </a:prstGeom>
            <a:solidFill>
              <a:srgbClr val="ED7D3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矩形 27"/>
            <p:cNvSpPr/>
            <p:nvPr/>
          </p:nvSpPr>
          <p:spPr>
            <a:xfrm>
              <a:off x="1311174" y="8487965"/>
              <a:ext cx="108000" cy="108000"/>
            </a:xfrm>
            <a:prstGeom prst="rect">
              <a:avLst/>
            </a:prstGeom>
            <a:solidFill>
              <a:srgbClr val="5B9BD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1387090" y="8426549"/>
              <a:ext cx="19223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ression Percentage of isoform 1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3509010" y="8426549"/>
              <a:ext cx="19223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ression Percentage of isoform </a:t>
              </a:r>
              <a:r>
                <a:rPr lang="en-US" altLang="zh-CN" sz="9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文本框 2"/>
            <p:cNvSpPr txBox="1"/>
            <p:nvPr/>
          </p:nvSpPr>
          <p:spPr>
            <a:xfrm>
              <a:off x="2794774" y="2245053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3SS</a:t>
              </a:r>
              <a:endParaRPr lang="zh-CN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5735179" y="2245053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5SS</a:t>
              </a:r>
              <a:endParaRPr lang="zh-CN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1855792" y="4188661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3SS</a:t>
              </a:r>
              <a:endParaRPr lang="zh-CN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6014659" y="4188661"/>
              <a:ext cx="3850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</a:t>
              </a:r>
              <a:endParaRPr lang="zh-CN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4037668" y="4188661"/>
              <a:ext cx="4042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E</a:t>
              </a:r>
              <a:endParaRPr lang="zh-CN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1855792" y="6201530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5SS</a:t>
              </a:r>
              <a:endParaRPr lang="zh-CN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3838896" y="6201530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5SS</a:t>
              </a:r>
              <a:endParaRPr lang="zh-CN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6014659" y="6201530"/>
              <a:ext cx="4042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E</a:t>
              </a:r>
              <a:endParaRPr lang="zh-CN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1855792" y="8108398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3SS</a:t>
              </a:r>
              <a:endParaRPr lang="zh-CN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3838896" y="8108398"/>
              <a:ext cx="6030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3SS</a:t>
              </a:r>
              <a:endParaRPr lang="zh-CN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6014659" y="8108398"/>
              <a:ext cx="4042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E</a:t>
              </a:r>
              <a:endParaRPr lang="zh-CN" altLang="en-US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669331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7541" y="1408834"/>
            <a:ext cx="3589092" cy="3215312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5339870" y="734549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49953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/>
          <a:srcRect l="49094" r="41654"/>
          <a:stretch/>
        </p:blipFill>
        <p:spPr>
          <a:xfrm>
            <a:off x="3084162" y="995103"/>
            <a:ext cx="876925" cy="5090161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/>
          <a:srcRect l="35472" r="52666"/>
          <a:stretch/>
        </p:blipFill>
        <p:spPr>
          <a:xfrm>
            <a:off x="2012361" y="995103"/>
            <a:ext cx="1124262" cy="5090161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 rot="18601296">
            <a:off x="2050613" y="870440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MS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 rot="18601296">
            <a:off x="2327369" y="870440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S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 rot="18601296">
            <a:off x="2608389" y="87044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 rot="18601296">
            <a:off x="2841238" y="870440"/>
            <a:ext cx="3321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</a:t>
            </a:r>
            <a:endParaRPr lang="zh-CN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5339870" y="734549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1398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588</TotalTime>
  <Words>132</Words>
  <Application>Microsoft Office PowerPoint</Application>
  <PresentationFormat>全屏显示(4:3)</PresentationFormat>
  <Paragraphs>65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3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未定义</dc:creator>
  <cp:lastModifiedBy>未定义</cp:lastModifiedBy>
  <cp:revision>369</cp:revision>
  <cp:lastPrinted>2020-08-02T02:27:07Z</cp:lastPrinted>
  <dcterms:created xsi:type="dcterms:W3CDTF">2020-04-28T10:23:42Z</dcterms:created>
  <dcterms:modified xsi:type="dcterms:W3CDTF">2020-12-02T12:29:13Z</dcterms:modified>
</cp:coreProperties>
</file>